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076" y="-5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399862-DAC5-4C64-9146-C9F4C3DE9CE2}" type="datetimeFigureOut">
              <a:rPr lang="en-AU" smtClean="0"/>
              <a:t>19/06/2014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422005F-2DF9-4646-B354-B0A1E821502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141051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422005F-2DF9-4646-B354-B0A1E8215025}" type="slidenum">
              <a:rPr lang="en-AU" smtClean="0"/>
              <a:t>1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088275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89F357-D1DA-4D65-A6F3-A29B8255EF9F}" type="datetimeFigureOut">
              <a:rPr lang="en-AU" smtClean="0"/>
              <a:t>19/06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9E35A-B20E-4E2A-B116-FE5CE282884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04887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89F357-D1DA-4D65-A6F3-A29B8255EF9F}" type="datetimeFigureOut">
              <a:rPr lang="en-AU" smtClean="0"/>
              <a:t>19/06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9E35A-B20E-4E2A-B116-FE5CE282884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062115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89F357-D1DA-4D65-A6F3-A29B8255EF9F}" type="datetimeFigureOut">
              <a:rPr lang="en-AU" smtClean="0"/>
              <a:t>19/06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9E35A-B20E-4E2A-B116-FE5CE282884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831306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89F357-D1DA-4D65-A6F3-A29B8255EF9F}" type="datetimeFigureOut">
              <a:rPr lang="en-AU" smtClean="0"/>
              <a:t>19/06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9E35A-B20E-4E2A-B116-FE5CE282884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830881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89F357-D1DA-4D65-A6F3-A29B8255EF9F}" type="datetimeFigureOut">
              <a:rPr lang="en-AU" smtClean="0"/>
              <a:t>19/06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9E35A-B20E-4E2A-B116-FE5CE282884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059617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89F357-D1DA-4D65-A6F3-A29B8255EF9F}" type="datetimeFigureOut">
              <a:rPr lang="en-AU" smtClean="0"/>
              <a:t>19/06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9E35A-B20E-4E2A-B116-FE5CE282884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693452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89F357-D1DA-4D65-A6F3-A29B8255EF9F}" type="datetimeFigureOut">
              <a:rPr lang="en-AU" smtClean="0"/>
              <a:t>19/06/2014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9E35A-B20E-4E2A-B116-FE5CE282884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05723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89F357-D1DA-4D65-A6F3-A29B8255EF9F}" type="datetimeFigureOut">
              <a:rPr lang="en-AU" smtClean="0"/>
              <a:t>19/06/2014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9E35A-B20E-4E2A-B116-FE5CE282884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82578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89F357-D1DA-4D65-A6F3-A29B8255EF9F}" type="datetimeFigureOut">
              <a:rPr lang="en-AU" smtClean="0"/>
              <a:t>19/06/2014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9E35A-B20E-4E2A-B116-FE5CE282884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999842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89F357-D1DA-4D65-A6F3-A29B8255EF9F}" type="datetimeFigureOut">
              <a:rPr lang="en-AU" smtClean="0"/>
              <a:t>19/06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9E35A-B20E-4E2A-B116-FE5CE282884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393422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89F357-D1DA-4D65-A6F3-A29B8255EF9F}" type="datetimeFigureOut">
              <a:rPr lang="en-AU" smtClean="0"/>
              <a:t>19/06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9E35A-B20E-4E2A-B116-FE5CE282884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566784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89F357-D1DA-4D65-A6F3-A29B8255EF9F}" type="datetimeFigureOut">
              <a:rPr lang="en-AU" smtClean="0"/>
              <a:t>19/06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99E35A-B20E-4E2A-B116-FE5CE282884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216419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eg"/><Relationship Id="rId3" Type="http://schemas.openxmlformats.org/officeDocument/2006/relationships/image" Target="../media/image2.jpeg"/><Relationship Id="rId7" Type="http://schemas.openxmlformats.org/officeDocument/2006/relationships/image" Target="../media/image8.jpe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2.png"/><Relationship Id="rId5" Type="http://schemas.openxmlformats.org/officeDocument/2006/relationships/image" Target="../media/image4.jpeg"/><Relationship Id="rId10" Type="http://schemas.openxmlformats.org/officeDocument/2006/relationships/image" Target="../media/image11.png"/><Relationship Id="rId4" Type="http://schemas.openxmlformats.org/officeDocument/2006/relationships/image" Target="../media/image3.jpeg"/><Relationship Id="rId9" Type="http://schemas.openxmlformats.org/officeDocument/2006/relationships/image" Target="../media/image10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jpeg"/><Relationship Id="rId13" Type="http://schemas.openxmlformats.org/officeDocument/2006/relationships/image" Target="../media/image24.jpeg"/><Relationship Id="rId3" Type="http://schemas.openxmlformats.org/officeDocument/2006/relationships/image" Target="../media/image3.jpeg"/><Relationship Id="rId7" Type="http://schemas.openxmlformats.org/officeDocument/2006/relationships/image" Target="../media/image18.jpeg"/><Relationship Id="rId12" Type="http://schemas.openxmlformats.org/officeDocument/2006/relationships/image" Target="../media/image23.jpeg"/><Relationship Id="rId2" Type="http://schemas.openxmlformats.org/officeDocument/2006/relationships/image" Target="../media/image2.jpeg"/><Relationship Id="rId16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jpeg"/><Relationship Id="rId11" Type="http://schemas.openxmlformats.org/officeDocument/2006/relationships/image" Target="../media/image22.jpeg"/><Relationship Id="rId5" Type="http://schemas.openxmlformats.org/officeDocument/2006/relationships/image" Target="../media/image5.jpeg"/><Relationship Id="rId15" Type="http://schemas.openxmlformats.org/officeDocument/2006/relationships/image" Target="../media/image26.png"/><Relationship Id="rId10" Type="http://schemas.openxmlformats.org/officeDocument/2006/relationships/image" Target="../media/image21.jpeg"/><Relationship Id="rId4" Type="http://schemas.openxmlformats.org/officeDocument/2006/relationships/image" Target="../media/image4.jpeg"/><Relationship Id="rId9" Type="http://schemas.openxmlformats.org/officeDocument/2006/relationships/image" Target="../media/image20.jpeg"/><Relationship Id="rId14" Type="http://schemas.openxmlformats.org/officeDocument/2006/relationships/image" Target="../media/image25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jpeg"/><Relationship Id="rId13" Type="http://schemas.openxmlformats.org/officeDocument/2006/relationships/image" Target="../media/image35.jpeg"/><Relationship Id="rId18" Type="http://schemas.openxmlformats.org/officeDocument/2006/relationships/image" Target="../media/image40.jpeg"/><Relationship Id="rId3" Type="http://schemas.openxmlformats.org/officeDocument/2006/relationships/image" Target="../media/image3.jpeg"/><Relationship Id="rId7" Type="http://schemas.openxmlformats.org/officeDocument/2006/relationships/image" Target="../media/image29.jpeg"/><Relationship Id="rId12" Type="http://schemas.openxmlformats.org/officeDocument/2006/relationships/image" Target="../media/image34.jpeg"/><Relationship Id="rId17" Type="http://schemas.openxmlformats.org/officeDocument/2006/relationships/image" Target="../media/image39.jpeg"/><Relationship Id="rId2" Type="http://schemas.openxmlformats.org/officeDocument/2006/relationships/image" Target="../media/image2.jpeg"/><Relationship Id="rId16" Type="http://schemas.openxmlformats.org/officeDocument/2006/relationships/image" Target="../media/image3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jpeg"/><Relationship Id="rId11" Type="http://schemas.openxmlformats.org/officeDocument/2006/relationships/image" Target="../media/image33.jpeg"/><Relationship Id="rId5" Type="http://schemas.openxmlformats.org/officeDocument/2006/relationships/image" Target="../media/image5.jpeg"/><Relationship Id="rId15" Type="http://schemas.openxmlformats.org/officeDocument/2006/relationships/image" Target="../media/image37.jpeg"/><Relationship Id="rId10" Type="http://schemas.openxmlformats.org/officeDocument/2006/relationships/image" Target="../media/image32.jpeg"/><Relationship Id="rId19" Type="http://schemas.openxmlformats.org/officeDocument/2006/relationships/image" Target="../media/image41.jpeg"/><Relationship Id="rId4" Type="http://schemas.openxmlformats.org/officeDocument/2006/relationships/image" Target="../media/image4.jpeg"/><Relationship Id="rId9" Type="http://schemas.openxmlformats.org/officeDocument/2006/relationships/image" Target="../media/image31.jpeg"/><Relationship Id="rId14" Type="http://schemas.openxmlformats.org/officeDocument/2006/relationships/image" Target="../media/image36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5.png"/><Relationship Id="rId4" Type="http://schemas.openxmlformats.org/officeDocument/2006/relationships/image" Target="../media/image44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8.jpeg"/><Relationship Id="rId3" Type="http://schemas.openxmlformats.org/officeDocument/2006/relationships/image" Target="../media/image2.jpeg"/><Relationship Id="rId7" Type="http://schemas.openxmlformats.org/officeDocument/2006/relationships/image" Target="../media/image47.jpeg"/><Relationship Id="rId12" Type="http://schemas.openxmlformats.org/officeDocument/2006/relationships/image" Target="../media/image52.jpe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51.jpeg"/><Relationship Id="rId5" Type="http://schemas.openxmlformats.org/officeDocument/2006/relationships/image" Target="../media/image4.jpeg"/><Relationship Id="rId10" Type="http://schemas.openxmlformats.org/officeDocument/2006/relationships/image" Target="../media/image50.jpeg"/><Relationship Id="rId4" Type="http://schemas.openxmlformats.org/officeDocument/2006/relationships/image" Target="../media/image3.jpeg"/><Relationship Id="rId9" Type="http://schemas.openxmlformats.org/officeDocument/2006/relationships/image" Target="../media/image4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87419" y="290340"/>
            <a:ext cx="259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 smtClean="0"/>
              <a:t>A</a:t>
            </a:r>
            <a:endParaRPr lang="en-AU" sz="12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212745" y="3473617"/>
            <a:ext cx="259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 smtClean="0"/>
              <a:t>B</a:t>
            </a:r>
            <a:endParaRPr lang="en-AU" sz="1200" b="1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4345" y="567339"/>
            <a:ext cx="3960000" cy="21801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5" descr="C:\Users\s2820724\Documents\Lab\CoA synthesis inhibition\data for paper\Figures\Figure 7 timecourse\2014_Feb CoA timecourse\T0 DMSO rings 12um scalebar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9129" y="2792760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C:\Users\s2820724\Documents\Lab\CoA synthesis inhibition\data for paper\Figures\Figure 7 timecourse\2014_Feb CoA timecourse\T18 DMSO young trophs 12um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1153" y="2792760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458819" y="2924260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b="1" dirty="0" smtClean="0"/>
              <a:t>DMSO</a:t>
            </a:r>
            <a:endParaRPr lang="en-AU" sz="1200" b="1" dirty="0"/>
          </a:p>
        </p:txBody>
      </p:sp>
      <p:pic>
        <p:nvPicPr>
          <p:cNvPr id="1031" name="Picture 7" descr="C:\Users\s2820724\Documents\Lab\CoA synthesis inhibition\data for paper\Figures\Figure 7 timecourse\2014_Feb CoA timecourse\Figure 7 A\T24 DMSO middle troph 2 12um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23177" y="2792760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C:\Users\s2820724\Documents\Lab\CoA synthesis inhibition\data for paper\Figures\Figure 7 timecourse\2014_Feb CoA timecourse\Figure 7 A\T28 DMSO rings 2 12um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15202" y="2792760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1251874" y="3333987"/>
            <a:ext cx="3145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t0</a:t>
            </a:r>
            <a:endParaRPr lang="en-AU" sz="1200" dirty="0"/>
          </a:p>
        </p:txBody>
      </p:sp>
      <p:sp>
        <p:nvSpPr>
          <p:cNvPr id="18" name="TextBox 17"/>
          <p:cNvSpPr txBox="1"/>
          <p:nvPr/>
        </p:nvSpPr>
        <p:spPr>
          <a:xfrm>
            <a:off x="1804625" y="3333987"/>
            <a:ext cx="393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t18</a:t>
            </a:r>
            <a:endParaRPr lang="en-AU" sz="1200" dirty="0"/>
          </a:p>
        </p:txBody>
      </p:sp>
      <p:sp>
        <p:nvSpPr>
          <p:cNvPr id="19" name="TextBox 18"/>
          <p:cNvSpPr txBox="1"/>
          <p:nvPr/>
        </p:nvSpPr>
        <p:spPr>
          <a:xfrm>
            <a:off x="2396649" y="3333987"/>
            <a:ext cx="393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t24</a:t>
            </a:r>
            <a:endParaRPr lang="en-AU" sz="1200" dirty="0"/>
          </a:p>
        </p:txBody>
      </p:sp>
      <p:sp>
        <p:nvSpPr>
          <p:cNvPr id="20" name="TextBox 19"/>
          <p:cNvSpPr txBox="1"/>
          <p:nvPr/>
        </p:nvSpPr>
        <p:spPr>
          <a:xfrm>
            <a:off x="2988674" y="3333987"/>
            <a:ext cx="393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t48</a:t>
            </a:r>
            <a:endParaRPr lang="en-AU" sz="1200" dirty="0"/>
          </a:p>
        </p:txBody>
      </p:sp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3177" y="3872880"/>
            <a:ext cx="3960000" cy="21747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1302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42570" y="272480"/>
            <a:ext cx="259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 smtClean="0"/>
              <a:t>C</a:t>
            </a:r>
            <a:endParaRPr lang="en-AU" sz="1200" b="1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9120" y="568529"/>
            <a:ext cx="3960000" cy="21801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5" descr="C:\Users\s2820724\Documents\Lab\CoA synthesis inhibition\data for paper\Figures\Figure 7 timecourse\2014_Feb CoA timecourse\T0 DMSO rings 12um scalebar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1386" y="3394962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 descr="C:\Users\s2820724\Documents\Lab\CoA synthesis inhibition\data for paper\Figures\Figure 7 timecourse\2014_Feb CoA timecourse\T18 DMSO young trophs 12um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83410" y="3394962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311076" y="3526462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b="1" dirty="0" smtClean="0"/>
              <a:t>DMSO</a:t>
            </a:r>
            <a:endParaRPr lang="en-AU" sz="1200" b="1" dirty="0"/>
          </a:p>
        </p:txBody>
      </p:sp>
      <p:pic>
        <p:nvPicPr>
          <p:cNvPr id="9" name="Picture 7" descr="C:\Users\s2820724\Documents\Lab\CoA synthesis inhibition\data for paper\Figures\Figure 7 timecourse\2014_Feb CoA timecourse\Figure 7 A\T24 DMSO middle troph 2 12um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5434" y="3394962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8" descr="C:\Users\s2820724\Documents\Lab\CoA synthesis inhibition\data for paper\Figures\Figure 7 timecourse\2014_Feb CoA timecourse\Figure 7 A\T28 DMSO rings 2 12um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67459" y="3394962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1104131" y="3981183"/>
            <a:ext cx="3145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t0</a:t>
            </a:r>
            <a:endParaRPr lang="en-AU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1656882" y="3981183"/>
            <a:ext cx="393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t18</a:t>
            </a:r>
            <a:endParaRPr lang="en-AU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2248906" y="3981183"/>
            <a:ext cx="393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t24</a:t>
            </a:r>
            <a:endParaRPr lang="en-AU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2840931" y="3981183"/>
            <a:ext cx="393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t48</a:t>
            </a:r>
            <a:endParaRPr lang="en-AU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204961" y="2924260"/>
            <a:ext cx="10166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b="1" dirty="0" smtClean="0"/>
              <a:t>MMV665820</a:t>
            </a:r>
            <a:endParaRPr lang="en-AU" sz="1200" b="1" dirty="0"/>
          </a:p>
        </p:txBody>
      </p:sp>
      <p:pic>
        <p:nvPicPr>
          <p:cNvPr id="2051" name="Picture 3" descr="C:\Users\s2820724\Documents\Lab\CoA synthesis inhibition\data for paper\Figures\Supplementary Figure 1 timecourse\2014_Feb CoA timecourse\Supplementary Figure 1 C\T18 A3 new young troph 12um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83410" y="2794886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C:\Users\s2820724\Documents\Lab\CoA synthesis inhibition\data for paper\Figures\Supplementary Figure 1 timecourse\2014_Feb CoA timecourse\Supplementary Figure 1 C\T24 A3 new hedgehog irregular trophs2 12um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5434" y="2794886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C:\Users\s2820724\Documents\Lab\CoA synthesis inhibition\data for paper\Figures\Supplementary Figure 1 timecourse\2014_Feb CoA timecourse\Supplementary Figure 1 C\T48 A3 new young trophs 12um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67459" y="2794886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9120" y="6508576"/>
            <a:ext cx="3960000" cy="20970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9120" y="4293206"/>
            <a:ext cx="3960000" cy="21044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238440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12744" y="200472"/>
            <a:ext cx="259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D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80" y="477471"/>
            <a:ext cx="3960000" cy="2066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80" y="2648744"/>
            <a:ext cx="3960000" cy="21747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35318" y="4841769"/>
            <a:ext cx="259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 smtClean="0"/>
              <a:t>E</a:t>
            </a:r>
            <a:endParaRPr lang="en-AU" sz="1200" b="1" dirty="0"/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6104" y="5097016"/>
            <a:ext cx="3960000" cy="2066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634" y="7329264"/>
            <a:ext cx="3960000" cy="21747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403397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5" descr="C:\Users\s2820724\Documents\Lab\CoA synthesis inhibition\data for paper\Figures\Figure 7 timecourse\2014_Feb CoA timecourse\T0 DMSO rings 12um scalebar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1386" y="4161788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6" descr="C:\Users\s2820724\Documents\Lab\CoA synthesis inhibition\data for paper\Figures\Figure 7 timecourse\2014_Feb CoA timecourse\T18 DMSO young trophs 12um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83410" y="4161788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32656" y="4182404"/>
            <a:ext cx="369332" cy="50109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AU" sz="1200" b="1" dirty="0" smtClean="0"/>
              <a:t>DMSO</a:t>
            </a:r>
            <a:endParaRPr lang="en-AU" sz="1200" b="1" dirty="0"/>
          </a:p>
        </p:txBody>
      </p:sp>
      <p:pic>
        <p:nvPicPr>
          <p:cNvPr id="5" name="Picture 7" descr="C:\Users\s2820724\Documents\Lab\CoA synthesis inhibition\data for paper\Figures\Figure 7 timecourse\2014_Feb CoA timecourse\Figure 7 A\T24 DMSO middle troph 2 12um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5434" y="4161788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8" descr="C:\Users\s2820724\Documents\Lab\CoA synthesis inhibition\data for paper\Figures\Figure 7 timecourse\2014_Feb CoA timecourse\Figure 7 A\T28 DMSO rings 2 12um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67459" y="4161788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1104131" y="4748009"/>
            <a:ext cx="3145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t0</a:t>
            </a:r>
            <a:endParaRPr lang="en-AU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1656882" y="4748009"/>
            <a:ext cx="393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t18</a:t>
            </a:r>
            <a:endParaRPr lang="en-AU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2248906" y="4748009"/>
            <a:ext cx="393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t24</a:t>
            </a:r>
            <a:endParaRPr lang="en-AU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2840931" y="4748009"/>
            <a:ext cx="393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t48</a:t>
            </a:r>
            <a:endParaRPr lang="en-AU" sz="1200" dirty="0"/>
          </a:p>
        </p:txBody>
      </p:sp>
      <p:pic>
        <p:nvPicPr>
          <p:cNvPr id="11" name="Picture 5" descr="C:\Users\s2820724\Documents\Lab\CoA synthesis inhibition\data for paper\Figures\Supplementary Figure 1 timecourse\2014_Feb CoA timecourse\Supplementary Figure 1 E\T18 C5  contorted ring and ring 12um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83410" y="848544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6" descr="C:\Users\s2820724\Documents\Lab\CoA synthesis inhibition\data for paper\Figures\Supplementary Figure 1 timecourse\2014_Feb CoA timecourse\Supplementary Figure 1 E\T18 C5  dying ring 12um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83410" y="3055881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7" descr="C:\Users\s2820724\Documents\Lab\CoA synthesis inhibition\data for paper\Figures\Supplementary Figure 1 timecourse\2014_Feb CoA timecourse\Supplementary Figure 1 E\T18 C5  contorted and dead ing 12um 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83410" y="1945946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332656" y="1796460"/>
            <a:ext cx="369332" cy="92429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AU" sz="1200" b="1" dirty="0" smtClean="0"/>
              <a:t>MMV000570</a:t>
            </a:r>
            <a:endParaRPr lang="en-AU" sz="1200" b="1" dirty="0"/>
          </a:p>
        </p:txBody>
      </p:sp>
      <p:cxnSp>
        <p:nvCxnSpPr>
          <p:cNvPr id="15" name="Straight Connector 14"/>
          <p:cNvCxnSpPr/>
          <p:nvPr/>
        </p:nvCxnSpPr>
        <p:spPr>
          <a:xfrm flipH="1">
            <a:off x="684339" y="4161788"/>
            <a:ext cx="7881" cy="58622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" name="Picture 8" descr="C:\Users\s2820724\Documents\Lab\CoA synthesis inhibition\data for paper\Figures\Supplementary Figure 1 timecourse\2014_Feb CoA timecourse\Supplementary Figure 1 E\T24 C5 ring 12um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5434" y="848544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9" descr="C:\Users\s2820724\Documents\Lab\CoA synthesis inhibition\data for paper\Figures\Supplementary Figure 1 timecourse\2014_Feb CoA timecourse\Supplementary Figure 1 E\T24 C5 abnormal ring 12um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5434" y="1945946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10" descr="C:\Users\s2820724\Documents\Lab\CoA synthesis inhibition\data for paper\Figures\Supplementary Figure 1 timecourse\2014_Feb CoA timecourse\Supplementary Figure 1 E\T24 C5 dead ring 12um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5434" y="3055881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TextBox 18"/>
          <p:cNvSpPr txBox="1"/>
          <p:nvPr/>
        </p:nvSpPr>
        <p:spPr>
          <a:xfrm>
            <a:off x="684339" y="889263"/>
            <a:ext cx="94288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normal</a:t>
            </a:r>
            <a:r>
              <a:rPr lang="en-AU" sz="1200" dirty="0"/>
              <a:t/>
            </a:r>
            <a:br>
              <a:rPr lang="en-AU" sz="1200" dirty="0"/>
            </a:br>
            <a:r>
              <a:rPr lang="en-AU" sz="1200" dirty="0" smtClean="0"/>
              <a:t>morphology</a:t>
            </a:r>
            <a:endParaRPr lang="en-AU" sz="1200" dirty="0"/>
          </a:p>
        </p:txBody>
      </p:sp>
      <p:sp>
        <p:nvSpPr>
          <p:cNvPr id="20" name="TextBox 19"/>
          <p:cNvSpPr txBox="1"/>
          <p:nvPr/>
        </p:nvSpPr>
        <p:spPr>
          <a:xfrm>
            <a:off x="698790" y="2024280"/>
            <a:ext cx="94288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err="1" smtClean="0"/>
              <a:t>abormal</a:t>
            </a:r>
            <a:r>
              <a:rPr lang="en-AU" sz="1200" dirty="0"/>
              <a:t/>
            </a:r>
            <a:br>
              <a:rPr lang="en-AU" sz="1200" dirty="0"/>
            </a:br>
            <a:r>
              <a:rPr lang="en-AU" sz="1200" dirty="0" smtClean="0"/>
              <a:t>morphology</a:t>
            </a:r>
            <a:endParaRPr lang="en-AU" sz="1200" dirty="0"/>
          </a:p>
        </p:txBody>
      </p:sp>
      <p:sp>
        <p:nvSpPr>
          <p:cNvPr id="21" name="TextBox 20"/>
          <p:cNvSpPr txBox="1"/>
          <p:nvPr/>
        </p:nvSpPr>
        <p:spPr>
          <a:xfrm>
            <a:off x="666817" y="3095048"/>
            <a:ext cx="9621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/>
              <a:t>d</a:t>
            </a:r>
            <a:r>
              <a:rPr lang="en-AU" sz="1200" dirty="0" smtClean="0"/>
              <a:t>ead / dying</a:t>
            </a:r>
            <a:br>
              <a:rPr lang="en-AU" sz="1200" dirty="0" smtClean="0"/>
            </a:br>
            <a:r>
              <a:rPr lang="en-AU" sz="1200" dirty="0" smtClean="0"/>
              <a:t>parasites</a:t>
            </a:r>
            <a:endParaRPr lang="en-AU" sz="1200" dirty="0"/>
          </a:p>
        </p:txBody>
      </p:sp>
      <p:cxnSp>
        <p:nvCxnSpPr>
          <p:cNvPr id="22" name="Straight Connector 21"/>
          <p:cNvCxnSpPr/>
          <p:nvPr/>
        </p:nvCxnSpPr>
        <p:spPr>
          <a:xfrm>
            <a:off x="692220" y="889263"/>
            <a:ext cx="0" cy="313817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1627226" y="1388544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36%</a:t>
            </a:r>
            <a:endParaRPr lang="en-AU" sz="1200" dirty="0"/>
          </a:p>
        </p:txBody>
      </p:sp>
      <p:sp>
        <p:nvSpPr>
          <p:cNvPr id="25" name="TextBox 24"/>
          <p:cNvSpPr txBox="1"/>
          <p:nvPr/>
        </p:nvSpPr>
        <p:spPr>
          <a:xfrm>
            <a:off x="2206688" y="1388543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44%</a:t>
            </a:r>
            <a:endParaRPr lang="en-AU" sz="1200" dirty="0"/>
          </a:p>
        </p:txBody>
      </p:sp>
      <p:sp>
        <p:nvSpPr>
          <p:cNvPr id="26" name="TextBox 25"/>
          <p:cNvSpPr txBox="1"/>
          <p:nvPr/>
        </p:nvSpPr>
        <p:spPr>
          <a:xfrm>
            <a:off x="1627226" y="2487847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33%</a:t>
            </a:r>
            <a:endParaRPr lang="en-AU" sz="1200" dirty="0"/>
          </a:p>
        </p:txBody>
      </p:sp>
      <p:sp>
        <p:nvSpPr>
          <p:cNvPr id="27" name="TextBox 26"/>
          <p:cNvSpPr txBox="1"/>
          <p:nvPr/>
        </p:nvSpPr>
        <p:spPr>
          <a:xfrm>
            <a:off x="2219250" y="2485946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26%</a:t>
            </a:r>
            <a:endParaRPr lang="en-AU" sz="1200" dirty="0"/>
          </a:p>
        </p:txBody>
      </p:sp>
      <p:sp>
        <p:nvSpPr>
          <p:cNvPr id="28" name="TextBox 27"/>
          <p:cNvSpPr txBox="1"/>
          <p:nvPr/>
        </p:nvSpPr>
        <p:spPr>
          <a:xfrm>
            <a:off x="1642658" y="3595881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14%</a:t>
            </a:r>
            <a:endParaRPr lang="en-AU" sz="1200" dirty="0"/>
          </a:p>
        </p:txBody>
      </p:sp>
      <p:sp>
        <p:nvSpPr>
          <p:cNvPr id="29" name="TextBox 28"/>
          <p:cNvSpPr txBox="1"/>
          <p:nvPr/>
        </p:nvSpPr>
        <p:spPr>
          <a:xfrm>
            <a:off x="2206688" y="3595881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23%</a:t>
            </a:r>
            <a:endParaRPr lang="en-AU" sz="1200" dirty="0"/>
          </a:p>
        </p:txBody>
      </p:sp>
      <p:pic>
        <p:nvPicPr>
          <p:cNvPr id="2050" name="Picture 2" descr="C:\Users\s2820724\Documents\Lab\CoA synthesis inhibition\data for paper\Figures\Supplementary Figure 1 timecourse\2014_Feb CoA timecourse\Supplementary Figure 1 E\T48 C5 young troph 12um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67459" y="848544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C:\Users\s2820724\Documents\Lab\CoA synthesis inhibition\data for paper\Figures\Supplementary Figure 1 timecourse\2014_Feb CoA timecourse\Supplementary Figure 1 E\T48 C5 abnormal trophs 3 12um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67459" y="1945945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C:\Users\s2820724\Documents\Lab\CoA synthesis inhibition\data for paper\Figures\Supplementary Figure 1 timecourse\2014_Feb CoA timecourse\Supplementary Figure 1 E\T48 C5 dead and contorted ring 12um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67459" y="3055881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3" name="TextBox 32"/>
          <p:cNvSpPr txBox="1"/>
          <p:nvPr/>
        </p:nvSpPr>
        <p:spPr>
          <a:xfrm>
            <a:off x="1207729" y="1579657"/>
            <a:ext cx="8531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+ CoA 38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206688" y="1576409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39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206759" y="2659777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36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215369" y="2654993"/>
            <a:ext cx="8531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+ CoA 32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237470" y="3750440"/>
            <a:ext cx="8531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+ CoA 10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189594" y="3750440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13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2860167" y="1402443"/>
            <a:ext cx="373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/>
              <a:t>8</a:t>
            </a:r>
            <a:r>
              <a:rPr lang="en-AU" sz="1200" dirty="0" smtClean="0"/>
              <a:t>%</a:t>
            </a:r>
            <a:endParaRPr lang="en-AU" sz="1200" dirty="0"/>
          </a:p>
        </p:txBody>
      </p:sp>
      <p:sp>
        <p:nvSpPr>
          <p:cNvPr id="41" name="TextBox 40"/>
          <p:cNvSpPr txBox="1"/>
          <p:nvPr/>
        </p:nvSpPr>
        <p:spPr>
          <a:xfrm>
            <a:off x="2820893" y="1576408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42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820893" y="2479464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58%</a:t>
            </a:r>
            <a:endParaRPr lang="en-AU" sz="1200" dirty="0"/>
          </a:p>
        </p:txBody>
      </p:sp>
      <p:sp>
        <p:nvSpPr>
          <p:cNvPr id="43" name="TextBox 42"/>
          <p:cNvSpPr txBox="1"/>
          <p:nvPr/>
        </p:nvSpPr>
        <p:spPr>
          <a:xfrm>
            <a:off x="2820893" y="2659777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45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2792994" y="3581341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20%</a:t>
            </a:r>
            <a:endParaRPr lang="en-AU" sz="1200" dirty="0"/>
          </a:p>
        </p:txBody>
      </p:sp>
      <p:sp>
        <p:nvSpPr>
          <p:cNvPr id="45" name="TextBox 44"/>
          <p:cNvSpPr txBox="1"/>
          <p:nvPr/>
        </p:nvSpPr>
        <p:spPr>
          <a:xfrm>
            <a:off x="2850549" y="3750440"/>
            <a:ext cx="373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solidFill>
                  <a:srgbClr val="00B050"/>
                </a:solidFill>
              </a:rPr>
              <a:t>8</a:t>
            </a:r>
            <a:r>
              <a:rPr lang="en-AU" sz="1200" dirty="0" smtClean="0">
                <a:solidFill>
                  <a:srgbClr val="00B050"/>
                </a:solidFill>
              </a:rPr>
              <a:t>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235318" y="5025008"/>
            <a:ext cx="259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F</a:t>
            </a:r>
          </a:p>
        </p:txBody>
      </p:sp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7410" y="5313040"/>
            <a:ext cx="3960000" cy="20716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0270" y="7545288"/>
            <a:ext cx="3960000" cy="21072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250412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5" descr="C:\Users\s2820724\Documents\Lab\CoA synthesis inhibition\data for paper\Figures\Figure 7 timecourse\2014_Feb CoA timecourse\T0 DMSO rings 12um scalebar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6752" y="7258132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6" descr="C:\Users\s2820724\Documents\Lab\CoA synthesis inhibition\data for paper\Figures\Figure 7 timecourse\2014_Feb CoA timecourse\T18 DMSO young trophs 12um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8776" y="7258132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32656" y="7257256"/>
            <a:ext cx="369332" cy="50109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AU" sz="1200" b="1" dirty="0" smtClean="0"/>
              <a:t>DMSO</a:t>
            </a:r>
            <a:endParaRPr lang="en-AU" sz="1200" b="1" dirty="0"/>
          </a:p>
        </p:txBody>
      </p:sp>
      <p:pic>
        <p:nvPicPr>
          <p:cNvPr id="5" name="Picture 7" descr="C:\Users\s2820724\Documents\Lab\CoA synthesis inhibition\data for paper\Figures\Figure 7 timecourse\2014_Feb CoA timecourse\Figure 7 A\T24 DMSO middle troph 2 12um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80800" y="7258132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8" descr="C:\Users\s2820724\Documents\Lab\CoA synthesis inhibition\data for paper\Figures\Figure 7 timecourse\2014_Feb CoA timecourse\Figure 7 A\T28 DMSO rings 2 12um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2825" y="7258132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1309497" y="7844353"/>
            <a:ext cx="3145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t0</a:t>
            </a:r>
            <a:endParaRPr lang="en-AU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1862248" y="7844353"/>
            <a:ext cx="393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t18</a:t>
            </a:r>
            <a:endParaRPr lang="en-AU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2454272" y="7844353"/>
            <a:ext cx="393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t24</a:t>
            </a:r>
            <a:endParaRPr lang="en-AU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3046297" y="7844353"/>
            <a:ext cx="393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t48</a:t>
            </a:r>
            <a:endParaRPr lang="en-AU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332656" y="1796460"/>
            <a:ext cx="369332" cy="92429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AU" sz="1200" b="1" dirty="0" smtClean="0"/>
              <a:t>MMV011438</a:t>
            </a:r>
            <a:endParaRPr lang="en-AU" sz="1200" b="1" dirty="0"/>
          </a:p>
        </p:txBody>
      </p:sp>
      <p:cxnSp>
        <p:nvCxnSpPr>
          <p:cNvPr id="15" name="Straight Connector 14"/>
          <p:cNvCxnSpPr/>
          <p:nvPr/>
        </p:nvCxnSpPr>
        <p:spPr>
          <a:xfrm flipH="1">
            <a:off x="684339" y="7258132"/>
            <a:ext cx="7881" cy="58622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684339" y="889263"/>
            <a:ext cx="99899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Rings normal</a:t>
            </a:r>
            <a:r>
              <a:rPr lang="en-AU" sz="1200" dirty="0"/>
              <a:t/>
            </a:r>
            <a:br>
              <a:rPr lang="en-AU" sz="1200" dirty="0"/>
            </a:br>
            <a:r>
              <a:rPr lang="en-AU" sz="1200" dirty="0" smtClean="0"/>
              <a:t>morphology</a:t>
            </a:r>
            <a:endParaRPr lang="en-AU" sz="1200" dirty="0"/>
          </a:p>
        </p:txBody>
      </p:sp>
      <p:sp>
        <p:nvSpPr>
          <p:cNvPr id="20" name="TextBox 19"/>
          <p:cNvSpPr txBox="1"/>
          <p:nvPr/>
        </p:nvSpPr>
        <p:spPr>
          <a:xfrm>
            <a:off x="698790" y="2024280"/>
            <a:ext cx="10727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Rings </a:t>
            </a:r>
            <a:r>
              <a:rPr lang="en-AU" sz="1200" dirty="0" err="1" smtClean="0"/>
              <a:t>abormal</a:t>
            </a:r>
            <a:r>
              <a:rPr lang="en-AU" sz="1200" dirty="0"/>
              <a:t/>
            </a:r>
            <a:br>
              <a:rPr lang="en-AU" sz="1200" dirty="0"/>
            </a:br>
            <a:r>
              <a:rPr lang="en-AU" sz="1200" dirty="0" smtClean="0"/>
              <a:t>morphology</a:t>
            </a:r>
            <a:endParaRPr lang="en-AU" sz="1200" dirty="0"/>
          </a:p>
        </p:txBody>
      </p:sp>
      <p:cxnSp>
        <p:nvCxnSpPr>
          <p:cNvPr id="22" name="Straight Connector 21"/>
          <p:cNvCxnSpPr/>
          <p:nvPr/>
        </p:nvCxnSpPr>
        <p:spPr>
          <a:xfrm>
            <a:off x="692220" y="889263"/>
            <a:ext cx="14927" cy="615270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1832273" y="1388544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32%</a:t>
            </a:r>
            <a:endParaRPr lang="en-AU" sz="1200" dirty="0"/>
          </a:p>
        </p:txBody>
      </p:sp>
      <p:sp>
        <p:nvSpPr>
          <p:cNvPr id="24" name="TextBox 23"/>
          <p:cNvSpPr txBox="1"/>
          <p:nvPr/>
        </p:nvSpPr>
        <p:spPr>
          <a:xfrm>
            <a:off x="2411735" y="1388543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26%</a:t>
            </a:r>
            <a:endParaRPr lang="en-AU" sz="1200" dirty="0"/>
          </a:p>
        </p:txBody>
      </p:sp>
      <p:sp>
        <p:nvSpPr>
          <p:cNvPr id="25" name="TextBox 24"/>
          <p:cNvSpPr txBox="1"/>
          <p:nvPr/>
        </p:nvSpPr>
        <p:spPr>
          <a:xfrm>
            <a:off x="1832273" y="2487847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23%</a:t>
            </a:r>
            <a:endParaRPr lang="en-AU" sz="1200" dirty="0"/>
          </a:p>
        </p:txBody>
      </p:sp>
      <p:sp>
        <p:nvSpPr>
          <p:cNvPr id="26" name="TextBox 25"/>
          <p:cNvSpPr txBox="1"/>
          <p:nvPr/>
        </p:nvSpPr>
        <p:spPr>
          <a:xfrm>
            <a:off x="2424297" y="2485946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12%</a:t>
            </a:r>
            <a:endParaRPr lang="en-AU" sz="1200" dirty="0"/>
          </a:p>
        </p:txBody>
      </p:sp>
      <p:sp>
        <p:nvSpPr>
          <p:cNvPr id="32" name="TextBox 31"/>
          <p:cNvSpPr txBox="1"/>
          <p:nvPr/>
        </p:nvSpPr>
        <p:spPr>
          <a:xfrm>
            <a:off x="1412776" y="1579657"/>
            <a:ext cx="8531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+ CoA 41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2411735" y="1576409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25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479116" y="2659777"/>
            <a:ext cx="373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4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420416" y="2654993"/>
            <a:ext cx="8531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+ CoA 16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102357" y="1402443"/>
            <a:ext cx="373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2%</a:t>
            </a:r>
            <a:endParaRPr lang="en-AU" sz="1200" dirty="0"/>
          </a:p>
        </p:txBody>
      </p:sp>
      <p:sp>
        <p:nvSpPr>
          <p:cNvPr id="39" name="TextBox 38"/>
          <p:cNvSpPr txBox="1"/>
          <p:nvPr/>
        </p:nvSpPr>
        <p:spPr>
          <a:xfrm>
            <a:off x="3025940" y="1576408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34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096205" y="2479464"/>
            <a:ext cx="373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/>
              <a:t>0</a:t>
            </a:r>
            <a:r>
              <a:rPr lang="en-AU" sz="1200" dirty="0" smtClean="0"/>
              <a:t>%</a:t>
            </a:r>
            <a:endParaRPr lang="en-AU" sz="1200" dirty="0"/>
          </a:p>
        </p:txBody>
      </p:sp>
      <p:sp>
        <p:nvSpPr>
          <p:cNvPr id="41" name="TextBox 40"/>
          <p:cNvSpPr txBox="1"/>
          <p:nvPr/>
        </p:nvSpPr>
        <p:spPr>
          <a:xfrm>
            <a:off x="3025940" y="2659777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33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701988" y="2955618"/>
            <a:ext cx="98462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err="1" smtClean="0"/>
              <a:t>Trophozoites</a:t>
            </a:r>
            <a:r>
              <a:rPr lang="en-AU" sz="1200" dirty="0"/>
              <a:t/>
            </a:r>
            <a:br>
              <a:rPr lang="en-AU" sz="1200" dirty="0"/>
            </a:br>
            <a:r>
              <a:rPr lang="en-AU" sz="1200" dirty="0" smtClean="0"/>
              <a:t>normal</a:t>
            </a:r>
            <a:r>
              <a:rPr lang="en-AU" sz="1200" dirty="0"/>
              <a:t/>
            </a:r>
            <a:br>
              <a:rPr lang="en-AU" sz="1200" dirty="0"/>
            </a:br>
            <a:r>
              <a:rPr lang="en-AU" sz="1200" dirty="0" smtClean="0"/>
              <a:t>morphology</a:t>
            </a:r>
            <a:endParaRPr lang="en-AU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692220" y="4053020"/>
            <a:ext cx="98462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err="1" smtClean="0"/>
              <a:t>Trophozoites</a:t>
            </a:r>
            <a:r>
              <a:rPr lang="en-AU" sz="1200" dirty="0"/>
              <a:t/>
            </a:r>
            <a:br>
              <a:rPr lang="en-AU" sz="1200" dirty="0"/>
            </a:br>
            <a:r>
              <a:rPr lang="en-AU" sz="1200" dirty="0" err="1" smtClean="0"/>
              <a:t>abormal</a:t>
            </a:r>
            <a:r>
              <a:rPr lang="en-AU" sz="1200" dirty="0"/>
              <a:t/>
            </a:r>
            <a:br>
              <a:rPr lang="en-AU" sz="1200" dirty="0"/>
            </a:br>
            <a:r>
              <a:rPr lang="en-AU" sz="1200" dirty="0" smtClean="0"/>
              <a:t>morphology</a:t>
            </a:r>
            <a:endParaRPr lang="en-AU" sz="1200" dirty="0"/>
          </a:p>
        </p:txBody>
      </p:sp>
      <p:sp>
        <p:nvSpPr>
          <p:cNvPr id="50" name="TextBox 49"/>
          <p:cNvSpPr txBox="1"/>
          <p:nvPr/>
        </p:nvSpPr>
        <p:spPr>
          <a:xfrm>
            <a:off x="1840630" y="3548784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28%</a:t>
            </a:r>
            <a:endParaRPr lang="en-AU" sz="1200" dirty="0"/>
          </a:p>
        </p:txBody>
      </p:sp>
      <p:sp>
        <p:nvSpPr>
          <p:cNvPr id="51" name="TextBox 50"/>
          <p:cNvSpPr txBox="1"/>
          <p:nvPr/>
        </p:nvSpPr>
        <p:spPr>
          <a:xfrm>
            <a:off x="2420092" y="3548783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30%</a:t>
            </a:r>
            <a:endParaRPr lang="en-AU" sz="1200" dirty="0"/>
          </a:p>
        </p:txBody>
      </p:sp>
      <p:sp>
        <p:nvSpPr>
          <p:cNvPr id="52" name="TextBox 51"/>
          <p:cNvSpPr txBox="1"/>
          <p:nvPr/>
        </p:nvSpPr>
        <p:spPr>
          <a:xfrm>
            <a:off x="1840630" y="4648087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12%</a:t>
            </a:r>
            <a:endParaRPr lang="en-AU" sz="1200" dirty="0"/>
          </a:p>
        </p:txBody>
      </p:sp>
      <p:sp>
        <p:nvSpPr>
          <p:cNvPr id="53" name="TextBox 52"/>
          <p:cNvSpPr txBox="1"/>
          <p:nvPr/>
        </p:nvSpPr>
        <p:spPr>
          <a:xfrm>
            <a:off x="2432654" y="4646186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20%</a:t>
            </a:r>
            <a:endParaRPr lang="en-AU" sz="1200" dirty="0"/>
          </a:p>
        </p:txBody>
      </p:sp>
      <p:sp>
        <p:nvSpPr>
          <p:cNvPr id="56" name="TextBox 55"/>
          <p:cNvSpPr txBox="1"/>
          <p:nvPr/>
        </p:nvSpPr>
        <p:spPr>
          <a:xfrm>
            <a:off x="1421133" y="3739897"/>
            <a:ext cx="8531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+ CoA 30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2420092" y="3736649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56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2420163" y="4820017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13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1484784" y="4815233"/>
            <a:ext cx="7745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+ CoA 5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3048640" y="3562683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25%</a:t>
            </a:r>
            <a:endParaRPr lang="en-AU" sz="1200" dirty="0"/>
          </a:p>
        </p:txBody>
      </p:sp>
      <p:sp>
        <p:nvSpPr>
          <p:cNvPr id="61" name="TextBox 60"/>
          <p:cNvSpPr txBox="1"/>
          <p:nvPr/>
        </p:nvSpPr>
        <p:spPr>
          <a:xfrm>
            <a:off x="3034297" y="3736648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10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3034297" y="4639704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34%</a:t>
            </a:r>
            <a:endParaRPr lang="en-AU" sz="1200" dirty="0"/>
          </a:p>
        </p:txBody>
      </p:sp>
      <p:sp>
        <p:nvSpPr>
          <p:cNvPr id="63" name="TextBox 62"/>
          <p:cNvSpPr txBox="1"/>
          <p:nvPr/>
        </p:nvSpPr>
        <p:spPr>
          <a:xfrm>
            <a:off x="3101531" y="4820017"/>
            <a:ext cx="373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solidFill>
                  <a:srgbClr val="00B050"/>
                </a:solidFill>
              </a:rPr>
              <a:t>0</a:t>
            </a:r>
            <a:r>
              <a:rPr lang="en-AU" sz="1200" dirty="0" smtClean="0">
                <a:solidFill>
                  <a:srgbClr val="00B050"/>
                </a:solidFill>
              </a:rPr>
              <a:t>%</a:t>
            </a:r>
            <a:endParaRPr lang="en-AU" sz="1200" dirty="0">
              <a:solidFill>
                <a:srgbClr val="00B050"/>
              </a:solidFill>
            </a:endParaRPr>
          </a:p>
        </p:txBody>
      </p:sp>
      <p:pic>
        <p:nvPicPr>
          <p:cNvPr id="3074" name="Picture 2" descr="C:\Users\s2820724\Documents\Lab\CoA synthesis inhibition\data for paper\Figures\Supplementary Figure 1 timecourse\2014_Feb CoA timecourse\Supplementary Figure 1 F\T18 C9 young troph 12um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3280" y="3022683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C:\Users\s2820724\Documents\Lab\CoA synthesis inhibition\data for paper\Figures\Supplementary Figure 1 timecourse\2014_Feb CoA timecourse\Supplementary Figure 1 F\T18 C9  irregular young troph 12um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2998" y="4099704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 descr="C:\Users\s2820724\Documents\Lab\CoA synthesis inhibition\data for paper\Figures\Supplementary Figure 1 timecourse\2014_Feb CoA timecourse\Supplementary Figure 1 F\T18 C9 contorted rings 12um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8457" y="1945945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7" name="Picture 5" descr="C:\Users\s2820724\Documents\Lab\CoA synthesis inhibition\data for paper\Figures\Supplementary Figure 1 timecourse\2014_Feb CoA timecourse\Supplementary Figure 1 F\T18 C9 ring and irregular young troph 12um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8457" y="844688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8" name="Picture 6" descr="C:\Users\s2820724\Documents\Lab\CoA synthesis inhibition\data for paper\Figures\Supplementary Figure 1 timecourse\2014_Feb CoA timecourse\Supplementary Figure 1 F\T24 C9 abnormal troph 12um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80481" y="4092617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9" name="Picture 7" descr="C:\Users\s2820724\Documents\Lab\CoA synthesis inhibition\data for paper\Figures\Supplementary Figure 1 timecourse\2014_Feb CoA timecourse\Supplementary Figure 1 F\T24 C9 mid troph 12um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67919" y="3024182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0" name="Picture 8" descr="C:\Users\s2820724\Documents\Lab\CoA synthesis inhibition\data for paper\Figures\Supplementary Figure 1 timecourse\2014_Feb CoA timecourse\Supplementary Figure 1 F\T24 C9  ring 12um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67919" y="844688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1" name="Picture 9" descr="C:\Users\s2820724\Documents\Lab\CoA synthesis inhibition\data for paper\Figures\Supplementary Figure 1 timecourse\2014_Feb CoA timecourse\Supplementary Figure 1 F\T24 C9 abnormal ring 12um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61186" y="1939464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4" name="TextBox 73"/>
          <p:cNvSpPr txBox="1"/>
          <p:nvPr/>
        </p:nvSpPr>
        <p:spPr>
          <a:xfrm>
            <a:off x="692220" y="5078307"/>
            <a:ext cx="94288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err="1" smtClean="0"/>
              <a:t>Schizonts</a:t>
            </a:r>
            <a:r>
              <a:rPr lang="en-AU" sz="1200" dirty="0" smtClean="0"/>
              <a:t/>
            </a:r>
            <a:br>
              <a:rPr lang="en-AU" sz="1200" dirty="0" smtClean="0"/>
            </a:br>
            <a:r>
              <a:rPr lang="en-AU" sz="1200" dirty="0" smtClean="0"/>
              <a:t>normal</a:t>
            </a:r>
            <a:r>
              <a:rPr lang="en-AU" sz="1200" dirty="0"/>
              <a:t/>
            </a:r>
            <a:br>
              <a:rPr lang="en-AU" sz="1200" dirty="0"/>
            </a:br>
            <a:r>
              <a:rPr lang="en-AU" sz="1200" dirty="0" smtClean="0"/>
              <a:t>morphology</a:t>
            </a:r>
            <a:endParaRPr lang="en-AU" sz="1200" dirty="0"/>
          </a:p>
        </p:txBody>
      </p:sp>
      <p:sp>
        <p:nvSpPr>
          <p:cNvPr id="75" name="TextBox 74"/>
          <p:cNvSpPr txBox="1"/>
          <p:nvPr/>
        </p:nvSpPr>
        <p:spPr>
          <a:xfrm>
            <a:off x="707147" y="6102755"/>
            <a:ext cx="94288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err="1" smtClean="0"/>
              <a:t>Schizonts</a:t>
            </a:r>
            <a:r>
              <a:rPr lang="en-AU" sz="1200" dirty="0"/>
              <a:t/>
            </a:r>
            <a:br>
              <a:rPr lang="en-AU" sz="1200" dirty="0"/>
            </a:br>
            <a:r>
              <a:rPr lang="en-AU" sz="1200" dirty="0" err="1" smtClean="0"/>
              <a:t>abormal</a:t>
            </a:r>
            <a:r>
              <a:rPr lang="en-AU" sz="1200" dirty="0"/>
              <a:t/>
            </a:r>
            <a:br>
              <a:rPr lang="en-AU" sz="1200" dirty="0"/>
            </a:br>
            <a:r>
              <a:rPr lang="en-AU" sz="1200" dirty="0" smtClean="0"/>
              <a:t>morphology</a:t>
            </a:r>
            <a:endParaRPr lang="en-AU" sz="1200" dirty="0"/>
          </a:p>
        </p:txBody>
      </p:sp>
      <p:sp>
        <p:nvSpPr>
          <p:cNvPr id="77" name="TextBox 76"/>
          <p:cNvSpPr txBox="1"/>
          <p:nvPr/>
        </p:nvSpPr>
        <p:spPr>
          <a:xfrm>
            <a:off x="3112845" y="5684148"/>
            <a:ext cx="373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0%</a:t>
            </a:r>
            <a:endParaRPr lang="en-AU" sz="1200" dirty="0"/>
          </a:p>
        </p:txBody>
      </p:sp>
      <p:sp>
        <p:nvSpPr>
          <p:cNvPr id="79" name="TextBox 78"/>
          <p:cNvSpPr txBox="1"/>
          <p:nvPr/>
        </p:nvSpPr>
        <p:spPr>
          <a:xfrm>
            <a:off x="3081202" y="6734418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25%</a:t>
            </a:r>
            <a:endParaRPr lang="en-AU" sz="1200" dirty="0"/>
          </a:p>
        </p:txBody>
      </p:sp>
      <p:sp>
        <p:nvSpPr>
          <p:cNvPr id="80" name="TextBox 79"/>
          <p:cNvSpPr txBox="1"/>
          <p:nvPr/>
        </p:nvSpPr>
        <p:spPr>
          <a:xfrm>
            <a:off x="2637919" y="5877750"/>
            <a:ext cx="8531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+ CoA 19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2798445" y="6903465"/>
            <a:ext cx="7745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+ CoA 1%</a:t>
            </a:r>
            <a:endParaRPr lang="en-AU" sz="1200" dirty="0">
              <a:solidFill>
                <a:srgbClr val="00B050"/>
              </a:solidFill>
            </a:endParaRPr>
          </a:p>
        </p:txBody>
      </p:sp>
      <p:pic>
        <p:nvPicPr>
          <p:cNvPr id="3082" name="Picture 10" descr="C:\Users\s2820724\Documents\Lab\CoA synthesis inhibition\data for paper\Figures\Supplementary Figure 1 timecourse\2014_Feb CoA timecourse\Supplementary Figure 1 F\T48 C9 normal mid troph 12um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61008" y="3008784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3" name="Picture 11" descr="C:\Users\s2820724\Documents\Lab\CoA synthesis inhibition\data for paper\Figures\Supplementary Figure 1 timecourse\2014_Feb CoA timecourse\Supplementary Figure 1 F\T48 C9 + CoA contorted rings 12um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61008" y="1939464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4" name="Picture 12" descr="C:\Users\s2820724\Documents\Lab\CoA synthesis inhibition\data for paper\Figures\Supplementary Figure 1 timecourse\2014_Feb CoA timecourse\Supplementary Figure 1 F\T48 C9 + CoA matureschizont 12um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89801" y="5147719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5" name="Picture 13" descr="C:\Users\s2820724\Documents\Lab\CoA synthesis inhibition\data for paper\Figures\Supplementary Figure 1 timecourse\2014_Feb CoA timecourse\Supplementary Figure 1 F\T48 C9 + CoA ring 12um.jp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61008" y="844688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6" name="Picture 14" descr="C:\Users\s2820724\Documents\Lab\CoA synthesis inhibition\data for paper\Figures\Supplementary Figure 1 timecourse\2014_Feb CoA timecourse\Supplementary Figure 1 F\T48 C9 abnormal mature troph 2 12um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2825" y="4092617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7" name="Picture 15" descr="C:\Users\s2820724\Documents\Lab\CoA synthesis inhibition\data for paper\Figures\Supplementary Figure 1 timecourse\2014_Feb CoA timecourse\Supplementary Figure 1 F\T48 C9 abnormal young schizont 12um.jp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4824" y="6155920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394402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62309" y="272480"/>
            <a:ext cx="259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 smtClean="0"/>
              <a:t>G</a:t>
            </a:r>
            <a:endParaRPr lang="en-AU" sz="1200" b="1" dirty="0"/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672" y="549479"/>
            <a:ext cx="3960000" cy="2066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672" y="2720752"/>
            <a:ext cx="3960000" cy="21801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62309" y="4953000"/>
            <a:ext cx="259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H</a:t>
            </a:r>
          </a:p>
        </p:txBody>
      </p:sp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672" y="5229999"/>
            <a:ext cx="3960000" cy="21801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672" y="7545288"/>
            <a:ext cx="3960000" cy="21801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592503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2025" y="497418"/>
            <a:ext cx="3960000" cy="21072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5" descr="C:\Users\s2820724\Documents\Lab\CoA synthesis inhibition\data for paper\Figures\Figure 7 timecourse\2014_Feb CoA timecourse\T0 DMSO rings 12um scalebar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1386" y="5961112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6" descr="C:\Users\s2820724\Documents\Lab\CoA synthesis inhibition\data for paper\Figures\Figure 7 timecourse\2014_Feb CoA timecourse\T18 DMSO young trophs 12um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83410" y="5961112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332656" y="5981728"/>
            <a:ext cx="369332" cy="50109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AU" sz="1200" b="1" dirty="0" smtClean="0"/>
              <a:t>DMSO</a:t>
            </a:r>
            <a:endParaRPr lang="en-AU" sz="1200" b="1" dirty="0"/>
          </a:p>
        </p:txBody>
      </p:sp>
      <p:pic>
        <p:nvPicPr>
          <p:cNvPr id="7" name="Picture 7" descr="C:\Users\s2820724\Documents\Lab\CoA synthesis inhibition\data for paper\Figures\Figure 7 timecourse\2014_Feb CoA timecourse\Figure 7 A\T24 DMSO middle troph 2 12um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5434" y="5961112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8" descr="C:\Users\s2820724\Documents\Lab\CoA synthesis inhibition\data for paper\Figures\Figure 7 timecourse\2014_Feb CoA timecourse\Figure 7 A\T28 DMSO rings 2 12um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67459" y="5961112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1104131" y="6547333"/>
            <a:ext cx="3145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t0</a:t>
            </a:r>
            <a:endParaRPr lang="en-AU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1656882" y="6547333"/>
            <a:ext cx="393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t18</a:t>
            </a:r>
            <a:endParaRPr lang="en-AU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2248906" y="6547333"/>
            <a:ext cx="393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t24</a:t>
            </a:r>
            <a:endParaRPr lang="en-AU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2840931" y="6547333"/>
            <a:ext cx="393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t48</a:t>
            </a:r>
            <a:endParaRPr lang="en-AU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332656" y="3721440"/>
            <a:ext cx="369332" cy="94352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AU" sz="1200" b="1" dirty="0" smtClean="0"/>
              <a:t>Amb3377585</a:t>
            </a:r>
            <a:endParaRPr lang="en-AU" sz="1200" b="1" dirty="0"/>
          </a:p>
        </p:txBody>
      </p:sp>
      <p:cxnSp>
        <p:nvCxnSpPr>
          <p:cNvPr id="17" name="Straight Connector 16"/>
          <p:cNvCxnSpPr/>
          <p:nvPr/>
        </p:nvCxnSpPr>
        <p:spPr>
          <a:xfrm flipH="1">
            <a:off x="684339" y="5961112"/>
            <a:ext cx="7881" cy="58622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684339" y="2833479"/>
            <a:ext cx="94288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normal</a:t>
            </a:r>
            <a:r>
              <a:rPr lang="en-AU" sz="1200" dirty="0"/>
              <a:t/>
            </a:r>
            <a:br>
              <a:rPr lang="en-AU" sz="1200" dirty="0"/>
            </a:br>
            <a:r>
              <a:rPr lang="en-AU" sz="1200" dirty="0" smtClean="0"/>
              <a:t>morphology</a:t>
            </a:r>
            <a:endParaRPr lang="en-AU" sz="1200" dirty="0"/>
          </a:p>
        </p:txBody>
      </p:sp>
      <p:sp>
        <p:nvSpPr>
          <p:cNvPr id="22" name="TextBox 21"/>
          <p:cNvSpPr txBox="1"/>
          <p:nvPr/>
        </p:nvSpPr>
        <p:spPr>
          <a:xfrm>
            <a:off x="698790" y="3884249"/>
            <a:ext cx="94288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err="1" smtClean="0"/>
              <a:t>abormal</a:t>
            </a:r>
            <a:r>
              <a:rPr lang="en-AU" sz="1200" dirty="0"/>
              <a:t/>
            </a:r>
            <a:br>
              <a:rPr lang="en-AU" sz="1200" dirty="0"/>
            </a:br>
            <a:r>
              <a:rPr lang="en-AU" sz="1200" dirty="0" smtClean="0"/>
              <a:t>morphology</a:t>
            </a:r>
            <a:endParaRPr lang="en-AU" sz="1200" dirty="0"/>
          </a:p>
        </p:txBody>
      </p:sp>
      <p:sp>
        <p:nvSpPr>
          <p:cNvPr id="23" name="TextBox 22"/>
          <p:cNvSpPr txBox="1"/>
          <p:nvPr/>
        </p:nvSpPr>
        <p:spPr>
          <a:xfrm>
            <a:off x="666817" y="4955017"/>
            <a:ext cx="9621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/>
              <a:t>d</a:t>
            </a:r>
            <a:r>
              <a:rPr lang="en-AU" sz="1200" dirty="0" smtClean="0"/>
              <a:t>ead / dying</a:t>
            </a:r>
            <a:br>
              <a:rPr lang="en-AU" sz="1200" dirty="0" smtClean="0"/>
            </a:br>
            <a:r>
              <a:rPr lang="en-AU" sz="1200" dirty="0" smtClean="0"/>
              <a:t>parasites</a:t>
            </a:r>
            <a:endParaRPr lang="en-AU" sz="1200" dirty="0"/>
          </a:p>
        </p:txBody>
      </p:sp>
      <p:cxnSp>
        <p:nvCxnSpPr>
          <p:cNvPr id="24" name="Straight Connector 23"/>
          <p:cNvCxnSpPr/>
          <p:nvPr/>
        </p:nvCxnSpPr>
        <p:spPr>
          <a:xfrm>
            <a:off x="692220" y="2833479"/>
            <a:ext cx="0" cy="305392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1627226" y="3332760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47%</a:t>
            </a:r>
            <a:endParaRPr lang="en-AU" sz="1200" dirty="0"/>
          </a:p>
        </p:txBody>
      </p:sp>
      <p:sp>
        <p:nvSpPr>
          <p:cNvPr id="26" name="TextBox 25"/>
          <p:cNvSpPr txBox="1"/>
          <p:nvPr/>
        </p:nvSpPr>
        <p:spPr>
          <a:xfrm>
            <a:off x="2206688" y="3332759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28%</a:t>
            </a:r>
            <a:endParaRPr lang="en-AU" sz="1200" dirty="0"/>
          </a:p>
        </p:txBody>
      </p:sp>
      <p:sp>
        <p:nvSpPr>
          <p:cNvPr id="30" name="TextBox 29"/>
          <p:cNvSpPr txBox="1"/>
          <p:nvPr/>
        </p:nvSpPr>
        <p:spPr>
          <a:xfrm>
            <a:off x="2206688" y="5455850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49%</a:t>
            </a:r>
            <a:endParaRPr lang="en-AU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1207729" y="3523873"/>
            <a:ext cx="8531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+ CoA 39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206688" y="3520625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60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420888" y="4514962"/>
            <a:ext cx="8531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+ CoA 32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780128" y="5612105"/>
            <a:ext cx="8531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+ CoA 11%</a:t>
            </a:r>
            <a:endParaRPr lang="en-AU" sz="1200" dirty="0">
              <a:solidFill>
                <a:srgbClr val="00B050"/>
              </a:solidFill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820893" y="4339433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31%</a:t>
            </a:r>
            <a:endParaRPr lang="en-AU" sz="1200" dirty="0"/>
          </a:p>
        </p:txBody>
      </p:sp>
      <p:sp>
        <p:nvSpPr>
          <p:cNvPr id="44" name="TextBox 43"/>
          <p:cNvSpPr txBox="1"/>
          <p:nvPr/>
        </p:nvSpPr>
        <p:spPr>
          <a:xfrm>
            <a:off x="2792994" y="5441310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31%</a:t>
            </a:r>
            <a:endParaRPr lang="en-AU" sz="1200" dirty="0"/>
          </a:p>
        </p:txBody>
      </p:sp>
      <p:sp>
        <p:nvSpPr>
          <p:cNvPr id="45" name="TextBox 44"/>
          <p:cNvSpPr txBox="1"/>
          <p:nvPr/>
        </p:nvSpPr>
        <p:spPr>
          <a:xfrm>
            <a:off x="2850549" y="5610409"/>
            <a:ext cx="373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solidFill>
                  <a:srgbClr val="00B050"/>
                </a:solidFill>
              </a:rPr>
              <a:t>8</a:t>
            </a:r>
            <a:r>
              <a:rPr lang="en-AU" sz="1200" dirty="0" smtClean="0">
                <a:solidFill>
                  <a:srgbClr val="00B050"/>
                </a:solidFill>
              </a:rPr>
              <a:t>%</a:t>
            </a:r>
            <a:endParaRPr lang="en-AU" sz="1200" dirty="0">
              <a:solidFill>
                <a:srgbClr val="00B050"/>
              </a:solidFill>
            </a:endParaRPr>
          </a:p>
        </p:txBody>
      </p:sp>
      <p:pic>
        <p:nvPicPr>
          <p:cNvPr id="5123" name="Picture 3" descr="C:\Users\s2820724\Documents\Lab\CoA synthesis inhibition\data for paper\Figures\Supplementary Figure 1 timecourse\2014_Feb CoA timecourse\Supplementary Figure 1 H\T18 A3 + CoA  ring 12um 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5026" y="2792759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4" name="Picture 4" descr="C:\Users\s2820724\Documents\Lab\CoA synthesis inhibition\data for paper\Figures\Supplementary Figure 1 timecourse\2014_Feb CoA timecourse\Supplementary Figure 1 H\T24 A3 dying troph 12um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5434" y="4910307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5" name="Picture 5" descr="C:\Users\s2820724\Documents\Lab\CoA synthesis inhibition\data for paper\Figures\Supplementary Figure 1 timecourse\2014_Feb CoA timecourse\Supplementary Figure 1 H\T24 A3 troph 12um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5434" y="2792759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6" name="Picture 6" descr="C:\Users\s2820724\Documents\Lab\CoA synthesis inhibition\data for paper\Figures\Supplementary Figure 1 timecourse\2014_Feb CoA timecourse\Supplementary Figure 1 H\T48 A3 dead ring b12um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9178" y="4901310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2" name="Picture 12" descr="C:\Users\s2820724\Documents\Lab\CoA synthesis inhibition\data for paper\Figures\Supplementary Figure 1 timecourse\2014_Feb CoA timecourse\Supplementary Figure 1 H\T48 A3 irregular troph 12um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9178" y="3805914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4" name="Picture 14" descr="C:\Users\s2820724\Documents\Lab\CoA synthesis inhibition\data for paper\Figures\Supplementary Figure 1 timecourse\2014_Feb CoA timecourse\Supplementary Figure 1 H\T48 A3 mature troph 12um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9178" y="2792760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8" name="TextBox 57"/>
          <p:cNvSpPr txBox="1"/>
          <p:nvPr/>
        </p:nvSpPr>
        <p:spPr>
          <a:xfrm>
            <a:off x="2820202" y="3307839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30%</a:t>
            </a:r>
            <a:endParaRPr lang="en-AU" sz="1200" dirty="0"/>
          </a:p>
        </p:txBody>
      </p:sp>
      <p:sp>
        <p:nvSpPr>
          <p:cNvPr id="59" name="TextBox 58"/>
          <p:cNvSpPr txBox="1"/>
          <p:nvPr/>
        </p:nvSpPr>
        <p:spPr>
          <a:xfrm>
            <a:off x="2911164" y="3523873"/>
            <a:ext cx="373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solidFill>
                  <a:srgbClr val="00B050"/>
                </a:solidFill>
              </a:rPr>
              <a:t>6%</a:t>
            </a:r>
            <a:endParaRPr lang="en-AU" sz="1200" dirty="0">
              <a:solidFill>
                <a:srgbClr val="00B05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9150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9</TotalTime>
  <Words>196</Words>
  <Application>Microsoft Office PowerPoint</Application>
  <PresentationFormat>A4 Paper (210x297 mm)</PresentationFormat>
  <Paragraphs>108</Paragraphs>
  <Slides>7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Griffith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bine Mangold</dc:creator>
  <cp:lastModifiedBy>Sabine Mangold</cp:lastModifiedBy>
  <cp:revision>141</cp:revision>
  <dcterms:created xsi:type="dcterms:W3CDTF">2014-04-07T04:54:29Z</dcterms:created>
  <dcterms:modified xsi:type="dcterms:W3CDTF">2014-06-19T03:15:23Z</dcterms:modified>
</cp:coreProperties>
</file>